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 showGuides="1">
      <p:cViewPr varScale="1">
        <p:scale>
          <a:sx n="130" d="100"/>
          <a:sy n="130" d="100"/>
        </p:scale>
        <p:origin x="158" y="65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3BDFA7B-1728-1334-9863-3FDC30E2FF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6CD21D1-F957-1C20-9534-3D2845F45F6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074C0A9-17FC-060E-B2C9-1338EC1469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8A227-7E89-4F28-9749-8438A2838F8C}" type="datetimeFigureOut">
              <a:rPr kumimoji="1" lang="ja-JP" altLang="en-US" smtClean="0"/>
              <a:t>2022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8804C1C-8ABD-AD0D-9BD0-3809A61D7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AC4D62D-85B0-5709-4E0A-F312DD07F1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3B050-775C-4156-964A-8A2AE7E7E4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4008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8D8773F-2C6F-BAF6-5405-571318B0F8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3B4B4BD-3DAC-D2DE-4535-91C7F8E075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95476C0-584B-F7B1-853F-7047E8638B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8A227-7E89-4F28-9749-8438A2838F8C}" type="datetimeFigureOut">
              <a:rPr kumimoji="1" lang="ja-JP" altLang="en-US" smtClean="0"/>
              <a:t>2022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7B34B49-E439-B3CC-CED8-987629D98F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011583-6405-F125-DC6B-CA7C220D9B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3B050-775C-4156-964A-8A2AE7E7E4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2905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EA0CA82-C2A9-5676-2F28-2E3FF00935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241335A-8C81-D8B5-4B9A-8839C0C503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EDD7929-DDDE-BD22-2C84-C6820908CE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8A227-7E89-4F28-9749-8438A2838F8C}" type="datetimeFigureOut">
              <a:rPr kumimoji="1" lang="ja-JP" altLang="en-US" smtClean="0"/>
              <a:t>2022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3FD1BE3-1E8E-B943-20D7-E81971B6CC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FF4946A-F072-4337-B176-3B4E59C7B4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3B050-775C-4156-964A-8A2AE7E7E4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11453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7AEB99-7C52-802B-7A9B-58386B9609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FC35F19-BBFD-45BA-3446-BF5B4992F2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E25218A-E9D2-DF02-FE38-0F164B0F2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8A227-7E89-4F28-9749-8438A2838F8C}" type="datetimeFigureOut">
              <a:rPr kumimoji="1" lang="ja-JP" altLang="en-US" smtClean="0"/>
              <a:t>2022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58C9681-4569-234F-36A6-775D368DA8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EF3EA45-A8FD-B55D-7B5C-22F51470B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3B050-775C-4156-964A-8A2AE7E7E4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08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43771C-271F-8774-8E9B-80FC5242A7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BDA6773-7DC7-71A2-65F1-02A781E538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3AF4BE-D5BC-120D-4156-F3283EC03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8A227-7E89-4F28-9749-8438A2838F8C}" type="datetimeFigureOut">
              <a:rPr kumimoji="1" lang="ja-JP" altLang="en-US" smtClean="0"/>
              <a:t>2022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7C1B6B7-43E5-A8A7-9745-8800283DF4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1F58E0-A387-825F-AA1C-48F0E78960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3B050-775C-4156-964A-8A2AE7E7E4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086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405CA1-7449-6308-016D-2AFFFBCC8A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84C8B57-A1E6-5511-B819-F0F9F04D00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416D1B4-AE13-6E88-FB48-5EC06E7FC2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14FF401-748A-CBCD-FE1E-BA28C93B5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8A227-7E89-4F28-9749-8438A2838F8C}" type="datetimeFigureOut">
              <a:rPr kumimoji="1" lang="ja-JP" altLang="en-US" smtClean="0"/>
              <a:t>2022/1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D2ECC1D-71E2-7BB3-ADE6-C1F227CFC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6BFA2BA-EC16-A4FD-AC9A-F80FD098F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3B050-775C-4156-964A-8A2AE7E7E4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8239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FF466EE-0ADB-7797-092C-13BA0668C7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63BABE4-9A94-3F06-18CC-F340A70C02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322DCBC-C8C5-5688-0D97-01155B916C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8255E40-F95E-68B9-6C97-FB59837A1C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F3B9F1F-080C-6E72-CB12-090403C6C4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69155ECE-900C-B207-4469-1FE3F039EA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8A227-7E89-4F28-9749-8438A2838F8C}" type="datetimeFigureOut">
              <a:rPr kumimoji="1" lang="ja-JP" altLang="en-US" smtClean="0"/>
              <a:t>2022/11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1977FEB-0074-2317-D1B8-99DDF45403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237353B-4059-F8BD-0463-E0190BFD3D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3B050-775C-4156-964A-8A2AE7E7E4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6108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EB0E4D-5EFA-8C81-EE1F-242253A0EA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385BA4D-438C-8605-D2ED-0B7080E6B4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8A227-7E89-4F28-9749-8438A2838F8C}" type="datetimeFigureOut">
              <a:rPr kumimoji="1" lang="ja-JP" altLang="en-US" smtClean="0"/>
              <a:t>2022/11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236129C-C6A4-D1F6-5328-3C836A6D47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889E964-6273-C294-CC4B-B0B96D0D9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3B050-775C-4156-964A-8A2AE7E7E4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7704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44EB4D0-2E49-63F0-6966-1479E6FB09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8A227-7E89-4F28-9749-8438A2838F8C}" type="datetimeFigureOut">
              <a:rPr kumimoji="1" lang="ja-JP" altLang="en-US" smtClean="0"/>
              <a:t>2022/11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3CD5A74-BB0C-6CEF-FFF3-A9CBAB47A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F80562A-0F87-E331-98C5-CD6F5CD28F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3B050-775C-4156-964A-8A2AE7E7E4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43569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697306C-3A5A-03D6-D366-B0C8761577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EC4BC54-0621-158C-37B3-25375F4432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A2025AB-DF2E-978D-DDA2-BD9E1EA5A8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B5AF12-24B8-DBBF-9BAF-D2D0B49DCD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8A227-7E89-4F28-9749-8438A2838F8C}" type="datetimeFigureOut">
              <a:rPr kumimoji="1" lang="ja-JP" altLang="en-US" smtClean="0"/>
              <a:t>2022/1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81603F9-0F78-A0FF-D0A1-06EA9D81B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37824CF-EF96-B25C-41D4-0209CE209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3B050-775C-4156-964A-8A2AE7E7E4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5335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DB420D6-FA91-DAE8-95F5-C8B814F998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F78A5AD-E45D-ABBB-02CF-C9A5B1CAE73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22CC66D-EDB8-27D1-7BFE-62A6F27967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C05CAA1-0BB8-1AD6-0E3F-5AB9305188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88A227-7E89-4F28-9749-8438A2838F8C}" type="datetimeFigureOut">
              <a:rPr kumimoji="1" lang="ja-JP" altLang="en-US" smtClean="0"/>
              <a:t>2022/11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C225C19-025E-CFB8-78F4-7DC87165B9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E13B956-29FD-F7D4-1E74-7FC7760D53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A3B050-775C-4156-964A-8A2AE7E7E4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179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0148BE3-3B55-F2AB-1097-6B02F5C99A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600B009-6FB5-43DC-8E39-8DF38C3943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A0A5D5F-44D7-1FA7-A3AE-BE64252EF6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88A227-7E89-4F28-9749-8438A2838F8C}" type="datetimeFigureOut">
              <a:rPr kumimoji="1" lang="ja-JP" altLang="en-US" smtClean="0"/>
              <a:t>2022/11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BE3AD8F-B5F9-2792-E353-3DB469C29DF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8115863-448C-FE59-454B-4EF68D6051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A3B050-775C-4156-964A-8A2AE7E7E4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609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3" name="グループ化 92">
            <a:extLst>
              <a:ext uri="{FF2B5EF4-FFF2-40B4-BE49-F238E27FC236}">
                <a16:creationId xmlns:a16="http://schemas.microsoft.com/office/drawing/2014/main" id="{AE68F050-667E-871C-784D-AA927058E012}"/>
              </a:ext>
            </a:extLst>
          </p:cNvPr>
          <p:cNvGrpSpPr/>
          <p:nvPr/>
        </p:nvGrpSpPr>
        <p:grpSpPr>
          <a:xfrm>
            <a:off x="2805457" y="1132250"/>
            <a:ext cx="6878869" cy="4561968"/>
            <a:chOff x="2805458" y="1132250"/>
            <a:chExt cx="4903274" cy="3692032"/>
          </a:xfrm>
        </p:grpSpPr>
        <p:sp>
          <p:nvSpPr>
            <p:cNvPr id="8" name="Line 5">
              <a:extLst>
                <a:ext uri="{FF2B5EF4-FFF2-40B4-BE49-F238E27FC236}">
                  <a16:creationId xmlns:a16="http://schemas.microsoft.com/office/drawing/2014/main" id="{A02C8FAB-280D-4C14-0087-0C467CB5BD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19286" y="3616587"/>
              <a:ext cx="2781300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72DDA67C-0106-81F4-CCBA-5AA6A0DE52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19286" y="3616587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Line 7">
              <a:extLst>
                <a:ext uri="{FF2B5EF4-FFF2-40B4-BE49-F238E27FC236}">
                  <a16:creationId xmlns:a16="http://schemas.microsoft.com/office/drawing/2014/main" id="{9C818D53-A7BA-F65F-6574-784DA308B9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79661" y="3616587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Line 8">
              <a:extLst>
                <a:ext uri="{FF2B5EF4-FFF2-40B4-BE49-F238E27FC236}">
                  <a16:creationId xmlns:a16="http://schemas.microsoft.com/office/drawing/2014/main" id="{4B449943-00B3-304F-8956-8BF64C1C27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46386" y="3616587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Line 9">
              <a:extLst>
                <a:ext uri="{FF2B5EF4-FFF2-40B4-BE49-F238E27FC236}">
                  <a16:creationId xmlns:a16="http://schemas.microsoft.com/office/drawing/2014/main" id="{BFEFA41C-B9E9-F7D6-C1AB-6F7A512B989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506761" y="3616587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Line 10">
              <a:extLst>
                <a:ext uri="{FF2B5EF4-FFF2-40B4-BE49-F238E27FC236}">
                  <a16:creationId xmlns:a16="http://schemas.microsoft.com/office/drawing/2014/main" id="{F2572969-CD67-D762-0BF1-40D9671576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973486" y="3616587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Line 11">
              <a:extLst>
                <a:ext uri="{FF2B5EF4-FFF2-40B4-BE49-F238E27FC236}">
                  <a16:creationId xmlns:a16="http://schemas.microsoft.com/office/drawing/2014/main" id="{51AB5F04-036B-1B4A-F9C9-14A0DAEE2F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38624" y="3616587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Line 12">
              <a:extLst>
                <a:ext uri="{FF2B5EF4-FFF2-40B4-BE49-F238E27FC236}">
                  <a16:creationId xmlns:a16="http://schemas.microsoft.com/office/drawing/2014/main" id="{20B0F871-F893-578F-5074-537D5A57B4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00586" y="3616587"/>
              <a:ext cx="0" cy="5873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A80DD6AC-7EB8-9C05-E80A-3CF499E891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73249" y="3746762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F2FA9B3E-F811-D012-08BE-C3F2A045DA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5049" y="3746762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3A4B1ADA-27EA-91A3-4A4C-9A0AF0DC05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1774" y="3746762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3243133C-6A01-46E1-7979-2A7BF2F6A8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2149" y="3746762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B480E771-6460-998E-9EA2-CEB61CEE32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98874" y="3746762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8EBD24BF-8447-877E-84DF-6F4581E2CC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4011" y="3746762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507AC023-A932-F4CB-2202-12384B685D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25974" y="3746762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Line 20">
              <a:extLst>
                <a:ext uri="{FF2B5EF4-FFF2-40B4-BE49-F238E27FC236}">
                  <a16:creationId xmlns:a16="http://schemas.microsoft.com/office/drawing/2014/main" id="{8AE34E84-6B73-6416-3E83-9E1E99FBDA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08161" y="1314712"/>
              <a:ext cx="0" cy="221456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Line 21">
              <a:extLst>
                <a:ext uri="{FF2B5EF4-FFF2-40B4-BE49-F238E27FC236}">
                  <a16:creationId xmlns:a16="http://schemas.microsoft.com/office/drawing/2014/main" id="{805864B8-020F-B93E-DCCF-603D50D51D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49424" y="3529275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Line 22">
              <a:extLst>
                <a:ext uri="{FF2B5EF4-FFF2-40B4-BE49-F238E27FC236}">
                  <a16:creationId xmlns:a16="http://schemas.microsoft.com/office/drawing/2014/main" id="{F7A00413-6402-72CD-C7AD-F9E0764D14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49424" y="3086362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Line 23">
              <a:extLst>
                <a:ext uri="{FF2B5EF4-FFF2-40B4-BE49-F238E27FC236}">
                  <a16:creationId xmlns:a16="http://schemas.microsoft.com/office/drawing/2014/main" id="{174A94C8-0BE6-6C40-3925-28717FDD3A0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49424" y="2643450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Line 24">
              <a:extLst>
                <a:ext uri="{FF2B5EF4-FFF2-40B4-BE49-F238E27FC236}">
                  <a16:creationId xmlns:a16="http://schemas.microsoft.com/office/drawing/2014/main" id="{A001EB1C-FE56-EEBE-0B2B-A8824F57373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49424" y="2200537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Line 25">
              <a:extLst>
                <a:ext uri="{FF2B5EF4-FFF2-40B4-BE49-F238E27FC236}">
                  <a16:creationId xmlns:a16="http://schemas.microsoft.com/office/drawing/2014/main" id="{6D647450-E590-F7AD-DE89-B6233F6C00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49424" y="1757625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Line 26">
              <a:extLst>
                <a:ext uri="{FF2B5EF4-FFF2-40B4-BE49-F238E27FC236}">
                  <a16:creationId xmlns:a16="http://schemas.microsoft.com/office/drawing/2014/main" id="{DFFF0D5B-E52B-313B-D3E7-1B11590197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49424" y="1314712"/>
              <a:ext cx="58738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D1C353E6-E926-79A5-9CEC-3488EF1C1C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4118" y="3435061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16E7A882-33A0-DC47-ABF2-39590A3565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4118" y="2996911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691A3983-F6A8-ECFB-0DED-40BE2CD459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4118" y="2553999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4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94501207-BD78-E869-6F47-137DD8A35D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4118" y="2111086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1C6F9B9E-0B25-CF50-862B-E2E322F772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4118" y="1668174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8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2A499FDE-F063-DB11-F472-E604FCA191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4118" y="1225261"/>
              <a:ext cx="22442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Freeform 33">
              <a:extLst>
                <a:ext uri="{FF2B5EF4-FFF2-40B4-BE49-F238E27FC236}">
                  <a16:creationId xmlns:a16="http://schemas.microsoft.com/office/drawing/2014/main" id="{989A60EB-47CC-4B97-A53F-7550E924391E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8161" y="1225812"/>
              <a:ext cx="3001963" cy="2390775"/>
            </a:xfrm>
            <a:custGeom>
              <a:avLst/>
              <a:gdLst>
                <a:gd name="T0" fmla="*/ 0 w 515"/>
                <a:gd name="T1" fmla="*/ 0 h 410"/>
                <a:gd name="T2" fmla="*/ 0 w 515"/>
                <a:gd name="T3" fmla="*/ 410 h 410"/>
                <a:gd name="T4" fmla="*/ 515 w 515"/>
                <a:gd name="T5" fmla="*/ 410 h 4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410">
                  <a:moveTo>
                    <a:pt x="0" y="0"/>
                  </a:moveTo>
                  <a:lnTo>
                    <a:pt x="0" y="410"/>
                  </a:lnTo>
                  <a:lnTo>
                    <a:pt x="515" y="410"/>
                  </a:lnTo>
                </a:path>
              </a:pathLst>
            </a:cu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6251190D-5976-AD5F-A048-F367ED9B47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41269" y="3746762"/>
              <a:ext cx="56746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months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706F6BA4-0471-1E29-7EB5-2DC7EA5A3A8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2939038" y="2326178"/>
              <a:ext cx="86235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Probability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Freeform 36">
              <a:extLst>
                <a:ext uri="{FF2B5EF4-FFF2-40B4-BE49-F238E27FC236}">
                  <a16:creationId xmlns:a16="http://schemas.microsoft.com/office/drawing/2014/main" id="{C8296EB6-36F3-18C5-36F9-BD30D8031A67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9286" y="1314712"/>
              <a:ext cx="3124200" cy="1119188"/>
            </a:xfrm>
            <a:custGeom>
              <a:avLst/>
              <a:gdLst>
                <a:gd name="T0" fmla="*/ 0 w 536"/>
                <a:gd name="T1" fmla="*/ 0 h 192"/>
                <a:gd name="T2" fmla="*/ 12 w 536"/>
                <a:gd name="T3" fmla="*/ 0 h 192"/>
                <a:gd name="T4" fmla="*/ 12 w 536"/>
                <a:gd name="T5" fmla="*/ 10 h 192"/>
                <a:gd name="T6" fmla="*/ 23 w 536"/>
                <a:gd name="T7" fmla="*/ 10 h 192"/>
                <a:gd name="T8" fmla="*/ 23 w 536"/>
                <a:gd name="T9" fmla="*/ 21 h 192"/>
                <a:gd name="T10" fmla="*/ 24 w 536"/>
                <a:gd name="T11" fmla="*/ 21 h 192"/>
                <a:gd name="T12" fmla="*/ 24 w 536"/>
                <a:gd name="T13" fmla="*/ 31 h 192"/>
                <a:gd name="T14" fmla="*/ 35 w 536"/>
                <a:gd name="T15" fmla="*/ 31 h 192"/>
                <a:gd name="T16" fmla="*/ 35 w 536"/>
                <a:gd name="T17" fmla="*/ 42 h 192"/>
                <a:gd name="T18" fmla="*/ 45 w 536"/>
                <a:gd name="T19" fmla="*/ 42 h 192"/>
                <a:gd name="T20" fmla="*/ 45 w 536"/>
                <a:gd name="T21" fmla="*/ 53 h 192"/>
                <a:gd name="T22" fmla="*/ 46 w 536"/>
                <a:gd name="T23" fmla="*/ 53 h 192"/>
                <a:gd name="T24" fmla="*/ 46 w 536"/>
                <a:gd name="T25" fmla="*/ 64 h 192"/>
                <a:gd name="T26" fmla="*/ 54 w 536"/>
                <a:gd name="T27" fmla="*/ 64 h 192"/>
                <a:gd name="T28" fmla="*/ 54 w 536"/>
                <a:gd name="T29" fmla="*/ 75 h 192"/>
                <a:gd name="T30" fmla="*/ 66 w 536"/>
                <a:gd name="T31" fmla="*/ 75 h 192"/>
                <a:gd name="T32" fmla="*/ 66 w 536"/>
                <a:gd name="T33" fmla="*/ 86 h 192"/>
                <a:gd name="T34" fmla="*/ 69 w 536"/>
                <a:gd name="T35" fmla="*/ 86 h 192"/>
                <a:gd name="T36" fmla="*/ 69 w 536"/>
                <a:gd name="T37" fmla="*/ 98 h 192"/>
                <a:gd name="T38" fmla="*/ 86 w 536"/>
                <a:gd name="T39" fmla="*/ 98 h 192"/>
                <a:gd name="T40" fmla="*/ 86 w 536"/>
                <a:gd name="T41" fmla="*/ 109 h 192"/>
                <a:gd name="T42" fmla="*/ 87 w 536"/>
                <a:gd name="T43" fmla="*/ 109 h 192"/>
                <a:gd name="T44" fmla="*/ 87 w 536"/>
                <a:gd name="T45" fmla="*/ 121 h 192"/>
                <a:gd name="T46" fmla="*/ 101 w 536"/>
                <a:gd name="T47" fmla="*/ 121 h 192"/>
                <a:gd name="T48" fmla="*/ 101 w 536"/>
                <a:gd name="T49" fmla="*/ 133 h 192"/>
                <a:gd name="T50" fmla="*/ 115 w 536"/>
                <a:gd name="T51" fmla="*/ 133 h 192"/>
                <a:gd name="T52" fmla="*/ 115 w 536"/>
                <a:gd name="T53" fmla="*/ 147 h 192"/>
                <a:gd name="T54" fmla="*/ 165 w 536"/>
                <a:gd name="T55" fmla="*/ 147 h 192"/>
                <a:gd name="T56" fmla="*/ 165 w 536"/>
                <a:gd name="T57" fmla="*/ 161 h 192"/>
                <a:gd name="T58" fmla="*/ 382 w 536"/>
                <a:gd name="T59" fmla="*/ 161 h 192"/>
                <a:gd name="T60" fmla="*/ 382 w 536"/>
                <a:gd name="T61" fmla="*/ 192 h 192"/>
                <a:gd name="T62" fmla="*/ 536 w 536"/>
                <a:gd name="T63" fmla="*/ 192 h 1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</a:cxnLst>
              <a:rect l="0" t="0" r="r" b="b"/>
              <a:pathLst>
                <a:path w="536" h="192">
                  <a:moveTo>
                    <a:pt x="0" y="0"/>
                  </a:moveTo>
                  <a:lnTo>
                    <a:pt x="12" y="0"/>
                  </a:lnTo>
                  <a:lnTo>
                    <a:pt x="12" y="10"/>
                  </a:lnTo>
                  <a:lnTo>
                    <a:pt x="23" y="10"/>
                  </a:lnTo>
                  <a:lnTo>
                    <a:pt x="23" y="21"/>
                  </a:lnTo>
                  <a:lnTo>
                    <a:pt x="24" y="21"/>
                  </a:lnTo>
                  <a:lnTo>
                    <a:pt x="24" y="31"/>
                  </a:lnTo>
                  <a:lnTo>
                    <a:pt x="35" y="31"/>
                  </a:lnTo>
                  <a:lnTo>
                    <a:pt x="35" y="42"/>
                  </a:lnTo>
                  <a:lnTo>
                    <a:pt x="45" y="42"/>
                  </a:lnTo>
                  <a:lnTo>
                    <a:pt x="45" y="53"/>
                  </a:lnTo>
                  <a:lnTo>
                    <a:pt x="46" y="53"/>
                  </a:lnTo>
                  <a:lnTo>
                    <a:pt x="46" y="64"/>
                  </a:lnTo>
                  <a:lnTo>
                    <a:pt x="54" y="64"/>
                  </a:lnTo>
                  <a:lnTo>
                    <a:pt x="54" y="75"/>
                  </a:lnTo>
                  <a:lnTo>
                    <a:pt x="66" y="75"/>
                  </a:lnTo>
                  <a:lnTo>
                    <a:pt x="66" y="86"/>
                  </a:lnTo>
                  <a:lnTo>
                    <a:pt x="69" y="86"/>
                  </a:lnTo>
                  <a:lnTo>
                    <a:pt x="69" y="98"/>
                  </a:lnTo>
                  <a:lnTo>
                    <a:pt x="86" y="98"/>
                  </a:lnTo>
                  <a:lnTo>
                    <a:pt x="86" y="109"/>
                  </a:lnTo>
                  <a:lnTo>
                    <a:pt x="87" y="109"/>
                  </a:lnTo>
                  <a:lnTo>
                    <a:pt x="87" y="121"/>
                  </a:lnTo>
                  <a:lnTo>
                    <a:pt x="101" y="121"/>
                  </a:lnTo>
                  <a:lnTo>
                    <a:pt x="101" y="133"/>
                  </a:lnTo>
                  <a:lnTo>
                    <a:pt x="115" y="133"/>
                  </a:lnTo>
                  <a:lnTo>
                    <a:pt x="115" y="147"/>
                  </a:lnTo>
                  <a:lnTo>
                    <a:pt x="165" y="147"/>
                  </a:lnTo>
                  <a:lnTo>
                    <a:pt x="165" y="161"/>
                  </a:lnTo>
                  <a:lnTo>
                    <a:pt x="382" y="161"/>
                  </a:lnTo>
                  <a:lnTo>
                    <a:pt x="382" y="192"/>
                  </a:lnTo>
                  <a:lnTo>
                    <a:pt x="536" y="192"/>
                  </a:lnTo>
                </a:path>
              </a:pathLst>
            </a:cu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Freeform 37">
              <a:extLst>
                <a:ext uri="{FF2B5EF4-FFF2-40B4-BE49-F238E27FC236}">
                  <a16:creationId xmlns:a16="http://schemas.microsoft.com/office/drawing/2014/main" id="{7B6EEEEA-1D5E-73C4-E962-40E0A14A29D3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9286" y="1314712"/>
              <a:ext cx="3124200" cy="1771650"/>
            </a:xfrm>
            <a:custGeom>
              <a:avLst/>
              <a:gdLst>
                <a:gd name="T0" fmla="*/ 0 w 536"/>
                <a:gd name="T1" fmla="*/ 0 h 304"/>
                <a:gd name="T2" fmla="*/ 25 w 536"/>
                <a:gd name="T3" fmla="*/ 0 h 304"/>
                <a:gd name="T4" fmla="*/ 25 w 536"/>
                <a:gd name="T5" fmla="*/ 14 h 304"/>
                <a:gd name="T6" fmla="*/ 26 w 536"/>
                <a:gd name="T7" fmla="*/ 14 h 304"/>
                <a:gd name="T8" fmla="*/ 26 w 536"/>
                <a:gd name="T9" fmla="*/ 28 h 304"/>
                <a:gd name="T10" fmla="*/ 36 w 536"/>
                <a:gd name="T11" fmla="*/ 28 h 304"/>
                <a:gd name="T12" fmla="*/ 36 w 536"/>
                <a:gd name="T13" fmla="*/ 41 h 304"/>
                <a:gd name="T14" fmla="*/ 37 w 536"/>
                <a:gd name="T15" fmla="*/ 41 h 304"/>
                <a:gd name="T16" fmla="*/ 37 w 536"/>
                <a:gd name="T17" fmla="*/ 55 h 304"/>
                <a:gd name="T18" fmla="*/ 39 w 536"/>
                <a:gd name="T19" fmla="*/ 55 h 304"/>
                <a:gd name="T20" fmla="*/ 39 w 536"/>
                <a:gd name="T21" fmla="*/ 68 h 304"/>
                <a:gd name="T22" fmla="*/ 42 w 536"/>
                <a:gd name="T23" fmla="*/ 68 h 304"/>
                <a:gd name="T24" fmla="*/ 42 w 536"/>
                <a:gd name="T25" fmla="*/ 82 h 304"/>
                <a:gd name="T26" fmla="*/ 71 w 536"/>
                <a:gd name="T27" fmla="*/ 82 h 304"/>
                <a:gd name="T28" fmla="*/ 71 w 536"/>
                <a:gd name="T29" fmla="*/ 95 h 304"/>
                <a:gd name="T30" fmla="*/ 73 w 536"/>
                <a:gd name="T31" fmla="*/ 95 h 304"/>
                <a:gd name="T32" fmla="*/ 73 w 536"/>
                <a:gd name="T33" fmla="*/ 109 h 304"/>
                <a:gd name="T34" fmla="*/ 74 w 536"/>
                <a:gd name="T35" fmla="*/ 109 h 304"/>
                <a:gd name="T36" fmla="*/ 74 w 536"/>
                <a:gd name="T37" fmla="*/ 122 h 304"/>
                <a:gd name="T38" fmla="*/ 95 w 536"/>
                <a:gd name="T39" fmla="*/ 122 h 304"/>
                <a:gd name="T40" fmla="*/ 95 w 536"/>
                <a:gd name="T41" fmla="*/ 136 h 304"/>
                <a:gd name="T42" fmla="*/ 98 w 536"/>
                <a:gd name="T43" fmla="*/ 136 h 304"/>
                <a:gd name="T44" fmla="*/ 98 w 536"/>
                <a:gd name="T45" fmla="*/ 163 h 304"/>
                <a:gd name="T46" fmla="*/ 133 w 536"/>
                <a:gd name="T47" fmla="*/ 163 h 304"/>
                <a:gd name="T48" fmla="*/ 133 w 536"/>
                <a:gd name="T49" fmla="*/ 178 h 304"/>
                <a:gd name="T50" fmla="*/ 142 w 536"/>
                <a:gd name="T51" fmla="*/ 178 h 304"/>
                <a:gd name="T52" fmla="*/ 142 w 536"/>
                <a:gd name="T53" fmla="*/ 193 h 304"/>
                <a:gd name="T54" fmla="*/ 155 w 536"/>
                <a:gd name="T55" fmla="*/ 193 h 304"/>
                <a:gd name="T56" fmla="*/ 155 w 536"/>
                <a:gd name="T57" fmla="*/ 210 h 304"/>
                <a:gd name="T58" fmla="*/ 182 w 536"/>
                <a:gd name="T59" fmla="*/ 210 h 304"/>
                <a:gd name="T60" fmla="*/ 182 w 536"/>
                <a:gd name="T61" fmla="*/ 227 h 304"/>
                <a:gd name="T62" fmla="*/ 197 w 536"/>
                <a:gd name="T63" fmla="*/ 227 h 304"/>
                <a:gd name="T64" fmla="*/ 197 w 536"/>
                <a:gd name="T65" fmla="*/ 246 h 304"/>
                <a:gd name="T66" fmla="*/ 199 w 536"/>
                <a:gd name="T67" fmla="*/ 246 h 304"/>
                <a:gd name="T68" fmla="*/ 199 w 536"/>
                <a:gd name="T69" fmla="*/ 265 h 304"/>
                <a:gd name="T70" fmla="*/ 374 w 536"/>
                <a:gd name="T71" fmla="*/ 265 h 304"/>
                <a:gd name="T72" fmla="*/ 374 w 536"/>
                <a:gd name="T73" fmla="*/ 304 h 304"/>
                <a:gd name="T74" fmla="*/ 536 w 536"/>
                <a:gd name="T75" fmla="*/ 304 h 3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536" h="304">
                  <a:moveTo>
                    <a:pt x="0" y="0"/>
                  </a:moveTo>
                  <a:lnTo>
                    <a:pt x="25" y="0"/>
                  </a:lnTo>
                  <a:lnTo>
                    <a:pt x="25" y="14"/>
                  </a:lnTo>
                  <a:lnTo>
                    <a:pt x="26" y="14"/>
                  </a:lnTo>
                  <a:lnTo>
                    <a:pt x="26" y="28"/>
                  </a:lnTo>
                  <a:lnTo>
                    <a:pt x="36" y="28"/>
                  </a:lnTo>
                  <a:lnTo>
                    <a:pt x="36" y="41"/>
                  </a:lnTo>
                  <a:lnTo>
                    <a:pt x="37" y="41"/>
                  </a:lnTo>
                  <a:lnTo>
                    <a:pt x="37" y="55"/>
                  </a:lnTo>
                  <a:lnTo>
                    <a:pt x="39" y="55"/>
                  </a:lnTo>
                  <a:lnTo>
                    <a:pt x="39" y="68"/>
                  </a:lnTo>
                  <a:lnTo>
                    <a:pt x="42" y="68"/>
                  </a:lnTo>
                  <a:lnTo>
                    <a:pt x="42" y="82"/>
                  </a:lnTo>
                  <a:lnTo>
                    <a:pt x="71" y="82"/>
                  </a:lnTo>
                  <a:lnTo>
                    <a:pt x="71" y="95"/>
                  </a:lnTo>
                  <a:lnTo>
                    <a:pt x="73" y="95"/>
                  </a:lnTo>
                  <a:lnTo>
                    <a:pt x="73" y="109"/>
                  </a:lnTo>
                  <a:lnTo>
                    <a:pt x="74" y="109"/>
                  </a:lnTo>
                  <a:lnTo>
                    <a:pt x="74" y="122"/>
                  </a:lnTo>
                  <a:lnTo>
                    <a:pt x="95" y="122"/>
                  </a:lnTo>
                  <a:lnTo>
                    <a:pt x="95" y="136"/>
                  </a:lnTo>
                  <a:lnTo>
                    <a:pt x="98" y="136"/>
                  </a:lnTo>
                  <a:lnTo>
                    <a:pt x="98" y="163"/>
                  </a:lnTo>
                  <a:lnTo>
                    <a:pt x="133" y="163"/>
                  </a:lnTo>
                  <a:lnTo>
                    <a:pt x="133" y="178"/>
                  </a:lnTo>
                  <a:lnTo>
                    <a:pt x="142" y="178"/>
                  </a:lnTo>
                  <a:lnTo>
                    <a:pt x="142" y="193"/>
                  </a:lnTo>
                  <a:lnTo>
                    <a:pt x="155" y="193"/>
                  </a:lnTo>
                  <a:lnTo>
                    <a:pt x="155" y="210"/>
                  </a:lnTo>
                  <a:lnTo>
                    <a:pt x="182" y="210"/>
                  </a:lnTo>
                  <a:lnTo>
                    <a:pt x="182" y="227"/>
                  </a:lnTo>
                  <a:lnTo>
                    <a:pt x="197" y="227"/>
                  </a:lnTo>
                  <a:lnTo>
                    <a:pt x="197" y="246"/>
                  </a:lnTo>
                  <a:lnTo>
                    <a:pt x="199" y="246"/>
                  </a:lnTo>
                  <a:lnTo>
                    <a:pt x="199" y="265"/>
                  </a:lnTo>
                  <a:lnTo>
                    <a:pt x="374" y="265"/>
                  </a:lnTo>
                  <a:lnTo>
                    <a:pt x="374" y="304"/>
                  </a:lnTo>
                  <a:lnTo>
                    <a:pt x="536" y="304"/>
                  </a:lnTo>
                </a:path>
              </a:pathLst>
            </a:cu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Freeform 38">
              <a:extLst>
                <a:ext uri="{FF2B5EF4-FFF2-40B4-BE49-F238E27FC236}">
                  <a16:creationId xmlns:a16="http://schemas.microsoft.com/office/drawing/2014/main" id="{2B4916C7-1DB3-BFD3-B869-8B58A71B7F1B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9286" y="1314712"/>
              <a:ext cx="3124200" cy="1976438"/>
            </a:xfrm>
            <a:custGeom>
              <a:avLst/>
              <a:gdLst>
                <a:gd name="T0" fmla="*/ 0 w 536"/>
                <a:gd name="T1" fmla="*/ 0 h 339"/>
                <a:gd name="T2" fmla="*/ 2 w 536"/>
                <a:gd name="T3" fmla="*/ 0 h 339"/>
                <a:gd name="T4" fmla="*/ 2 w 536"/>
                <a:gd name="T5" fmla="*/ 17 h 339"/>
                <a:gd name="T6" fmla="*/ 13 w 536"/>
                <a:gd name="T7" fmla="*/ 17 h 339"/>
                <a:gd name="T8" fmla="*/ 13 w 536"/>
                <a:gd name="T9" fmla="*/ 33 h 339"/>
                <a:gd name="T10" fmla="*/ 14 w 536"/>
                <a:gd name="T11" fmla="*/ 33 h 339"/>
                <a:gd name="T12" fmla="*/ 14 w 536"/>
                <a:gd name="T13" fmla="*/ 50 h 339"/>
                <a:gd name="T14" fmla="*/ 32 w 536"/>
                <a:gd name="T15" fmla="*/ 50 h 339"/>
                <a:gd name="T16" fmla="*/ 32 w 536"/>
                <a:gd name="T17" fmla="*/ 66 h 339"/>
                <a:gd name="T18" fmla="*/ 39 w 536"/>
                <a:gd name="T19" fmla="*/ 66 h 339"/>
                <a:gd name="T20" fmla="*/ 39 w 536"/>
                <a:gd name="T21" fmla="*/ 83 h 339"/>
                <a:gd name="T22" fmla="*/ 40 w 536"/>
                <a:gd name="T23" fmla="*/ 83 h 339"/>
                <a:gd name="T24" fmla="*/ 40 w 536"/>
                <a:gd name="T25" fmla="*/ 99 h 339"/>
                <a:gd name="T26" fmla="*/ 44 w 536"/>
                <a:gd name="T27" fmla="*/ 99 h 339"/>
                <a:gd name="T28" fmla="*/ 44 w 536"/>
                <a:gd name="T29" fmla="*/ 116 h 339"/>
                <a:gd name="T30" fmla="*/ 53 w 536"/>
                <a:gd name="T31" fmla="*/ 116 h 339"/>
                <a:gd name="T32" fmla="*/ 53 w 536"/>
                <a:gd name="T33" fmla="*/ 132 h 339"/>
                <a:gd name="T34" fmla="*/ 54 w 536"/>
                <a:gd name="T35" fmla="*/ 132 h 339"/>
                <a:gd name="T36" fmla="*/ 54 w 536"/>
                <a:gd name="T37" fmla="*/ 149 h 339"/>
                <a:gd name="T38" fmla="*/ 55 w 536"/>
                <a:gd name="T39" fmla="*/ 149 h 339"/>
                <a:gd name="T40" fmla="*/ 55 w 536"/>
                <a:gd name="T41" fmla="*/ 167 h 339"/>
                <a:gd name="T42" fmla="*/ 94 w 536"/>
                <a:gd name="T43" fmla="*/ 167 h 339"/>
                <a:gd name="T44" fmla="*/ 94 w 536"/>
                <a:gd name="T45" fmla="*/ 197 h 339"/>
                <a:gd name="T46" fmla="*/ 100 w 536"/>
                <a:gd name="T47" fmla="*/ 197 h 339"/>
                <a:gd name="T48" fmla="*/ 100 w 536"/>
                <a:gd name="T49" fmla="*/ 228 h 339"/>
                <a:gd name="T50" fmla="*/ 108 w 536"/>
                <a:gd name="T51" fmla="*/ 228 h 339"/>
                <a:gd name="T52" fmla="*/ 108 w 536"/>
                <a:gd name="T53" fmla="*/ 258 h 339"/>
                <a:gd name="T54" fmla="*/ 224 w 536"/>
                <a:gd name="T55" fmla="*/ 258 h 339"/>
                <a:gd name="T56" fmla="*/ 224 w 536"/>
                <a:gd name="T57" fmla="*/ 299 h 339"/>
                <a:gd name="T58" fmla="*/ 336 w 536"/>
                <a:gd name="T59" fmla="*/ 299 h 339"/>
                <a:gd name="T60" fmla="*/ 336 w 536"/>
                <a:gd name="T61" fmla="*/ 339 h 339"/>
                <a:gd name="T62" fmla="*/ 536 w 536"/>
                <a:gd name="T63" fmla="*/ 339 h 3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</a:cxnLst>
              <a:rect l="0" t="0" r="r" b="b"/>
              <a:pathLst>
                <a:path w="536" h="339">
                  <a:moveTo>
                    <a:pt x="0" y="0"/>
                  </a:moveTo>
                  <a:lnTo>
                    <a:pt x="2" y="0"/>
                  </a:lnTo>
                  <a:lnTo>
                    <a:pt x="2" y="17"/>
                  </a:lnTo>
                  <a:lnTo>
                    <a:pt x="13" y="17"/>
                  </a:lnTo>
                  <a:lnTo>
                    <a:pt x="13" y="33"/>
                  </a:lnTo>
                  <a:lnTo>
                    <a:pt x="14" y="33"/>
                  </a:lnTo>
                  <a:lnTo>
                    <a:pt x="14" y="50"/>
                  </a:lnTo>
                  <a:lnTo>
                    <a:pt x="32" y="50"/>
                  </a:lnTo>
                  <a:lnTo>
                    <a:pt x="32" y="66"/>
                  </a:lnTo>
                  <a:lnTo>
                    <a:pt x="39" y="66"/>
                  </a:lnTo>
                  <a:lnTo>
                    <a:pt x="39" y="83"/>
                  </a:lnTo>
                  <a:lnTo>
                    <a:pt x="40" y="83"/>
                  </a:lnTo>
                  <a:lnTo>
                    <a:pt x="40" y="99"/>
                  </a:lnTo>
                  <a:lnTo>
                    <a:pt x="44" y="99"/>
                  </a:lnTo>
                  <a:lnTo>
                    <a:pt x="44" y="116"/>
                  </a:lnTo>
                  <a:lnTo>
                    <a:pt x="53" y="116"/>
                  </a:lnTo>
                  <a:lnTo>
                    <a:pt x="53" y="132"/>
                  </a:lnTo>
                  <a:lnTo>
                    <a:pt x="54" y="132"/>
                  </a:lnTo>
                  <a:lnTo>
                    <a:pt x="54" y="149"/>
                  </a:lnTo>
                  <a:lnTo>
                    <a:pt x="55" y="149"/>
                  </a:lnTo>
                  <a:lnTo>
                    <a:pt x="55" y="167"/>
                  </a:lnTo>
                  <a:lnTo>
                    <a:pt x="94" y="167"/>
                  </a:lnTo>
                  <a:lnTo>
                    <a:pt x="94" y="197"/>
                  </a:lnTo>
                  <a:lnTo>
                    <a:pt x="100" y="197"/>
                  </a:lnTo>
                  <a:lnTo>
                    <a:pt x="100" y="228"/>
                  </a:lnTo>
                  <a:lnTo>
                    <a:pt x="108" y="228"/>
                  </a:lnTo>
                  <a:lnTo>
                    <a:pt x="108" y="258"/>
                  </a:lnTo>
                  <a:lnTo>
                    <a:pt x="224" y="258"/>
                  </a:lnTo>
                  <a:lnTo>
                    <a:pt x="224" y="299"/>
                  </a:lnTo>
                  <a:lnTo>
                    <a:pt x="336" y="299"/>
                  </a:lnTo>
                  <a:lnTo>
                    <a:pt x="336" y="339"/>
                  </a:lnTo>
                  <a:lnTo>
                    <a:pt x="536" y="339"/>
                  </a:lnTo>
                </a:path>
              </a:pathLst>
            </a:custGeom>
            <a:noFill/>
            <a:ln w="28575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Freeform 39">
              <a:extLst>
                <a:ext uri="{FF2B5EF4-FFF2-40B4-BE49-F238E27FC236}">
                  <a16:creationId xmlns:a16="http://schemas.microsoft.com/office/drawing/2014/main" id="{02CA36F5-E8FE-CD98-43E1-4AA01816DD64}"/>
                </a:ext>
              </a:extLst>
            </p:cNvPr>
            <p:cNvSpPr>
              <a:spLocks/>
            </p:cNvSpPr>
            <p:nvPr/>
          </p:nvSpPr>
          <p:spPr bwMode="auto">
            <a:xfrm>
              <a:off x="4119286" y="1314712"/>
              <a:ext cx="2360613" cy="1958975"/>
            </a:xfrm>
            <a:custGeom>
              <a:avLst/>
              <a:gdLst>
                <a:gd name="T0" fmla="*/ 0 w 405"/>
                <a:gd name="T1" fmla="*/ 0 h 336"/>
                <a:gd name="T2" fmla="*/ 3 w 405"/>
                <a:gd name="T3" fmla="*/ 0 h 336"/>
                <a:gd name="T4" fmla="*/ 3 w 405"/>
                <a:gd name="T5" fmla="*/ 11 h 336"/>
                <a:gd name="T6" fmla="*/ 19 w 405"/>
                <a:gd name="T7" fmla="*/ 11 h 336"/>
                <a:gd name="T8" fmla="*/ 19 w 405"/>
                <a:gd name="T9" fmla="*/ 22 h 336"/>
                <a:gd name="T10" fmla="*/ 28 w 405"/>
                <a:gd name="T11" fmla="*/ 22 h 336"/>
                <a:gd name="T12" fmla="*/ 28 w 405"/>
                <a:gd name="T13" fmla="*/ 35 h 336"/>
                <a:gd name="T14" fmla="*/ 29 w 405"/>
                <a:gd name="T15" fmla="*/ 35 h 336"/>
                <a:gd name="T16" fmla="*/ 29 w 405"/>
                <a:gd name="T17" fmla="*/ 48 h 336"/>
                <a:gd name="T18" fmla="*/ 30 w 405"/>
                <a:gd name="T19" fmla="*/ 48 h 336"/>
                <a:gd name="T20" fmla="*/ 30 w 405"/>
                <a:gd name="T21" fmla="*/ 61 h 336"/>
                <a:gd name="T22" fmla="*/ 38 w 405"/>
                <a:gd name="T23" fmla="*/ 61 h 336"/>
                <a:gd name="T24" fmla="*/ 38 w 405"/>
                <a:gd name="T25" fmla="*/ 74 h 336"/>
                <a:gd name="T26" fmla="*/ 42 w 405"/>
                <a:gd name="T27" fmla="*/ 74 h 336"/>
                <a:gd name="T28" fmla="*/ 42 w 405"/>
                <a:gd name="T29" fmla="*/ 87 h 336"/>
                <a:gd name="T30" fmla="*/ 43 w 405"/>
                <a:gd name="T31" fmla="*/ 87 h 336"/>
                <a:gd name="T32" fmla="*/ 43 w 405"/>
                <a:gd name="T33" fmla="*/ 101 h 336"/>
                <a:gd name="T34" fmla="*/ 44 w 405"/>
                <a:gd name="T35" fmla="*/ 101 h 336"/>
                <a:gd name="T36" fmla="*/ 44 w 405"/>
                <a:gd name="T37" fmla="*/ 114 h 336"/>
                <a:gd name="T38" fmla="*/ 51 w 405"/>
                <a:gd name="T39" fmla="*/ 114 h 336"/>
                <a:gd name="T40" fmla="*/ 51 w 405"/>
                <a:gd name="T41" fmla="*/ 128 h 336"/>
                <a:gd name="T42" fmla="*/ 53 w 405"/>
                <a:gd name="T43" fmla="*/ 128 h 336"/>
                <a:gd name="T44" fmla="*/ 53 w 405"/>
                <a:gd name="T45" fmla="*/ 142 h 336"/>
                <a:gd name="T46" fmla="*/ 56 w 405"/>
                <a:gd name="T47" fmla="*/ 142 h 336"/>
                <a:gd name="T48" fmla="*/ 56 w 405"/>
                <a:gd name="T49" fmla="*/ 157 h 336"/>
                <a:gd name="T50" fmla="*/ 84 w 405"/>
                <a:gd name="T51" fmla="*/ 157 h 336"/>
                <a:gd name="T52" fmla="*/ 84 w 405"/>
                <a:gd name="T53" fmla="*/ 174 h 336"/>
                <a:gd name="T54" fmla="*/ 93 w 405"/>
                <a:gd name="T55" fmla="*/ 174 h 336"/>
                <a:gd name="T56" fmla="*/ 93 w 405"/>
                <a:gd name="T57" fmla="*/ 191 h 336"/>
                <a:gd name="T58" fmla="*/ 98 w 405"/>
                <a:gd name="T59" fmla="*/ 191 h 336"/>
                <a:gd name="T60" fmla="*/ 98 w 405"/>
                <a:gd name="T61" fmla="*/ 210 h 336"/>
                <a:gd name="T62" fmla="*/ 105 w 405"/>
                <a:gd name="T63" fmla="*/ 210 h 336"/>
                <a:gd name="T64" fmla="*/ 105 w 405"/>
                <a:gd name="T65" fmla="*/ 229 h 336"/>
                <a:gd name="T66" fmla="*/ 111 w 405"/>
                <a:gd name="T67" fmla="*/ 229 h 336"/>
                <a:gd name="T68" fmla="*/ 111 w 405"/>
                <a:gd name="T69" fmla="*/ 248 h 336"/>
                <a:gd name="T70" fmla="*/ 121 w 405"/>
                <a:gd name="T71" fmla="*/ 248 h 336"/>
                <a:gd name="T72" fmla="*/ 121 w 405"/>
                <a:gd name="T73" fmla="*/ 270 h 336"/>
                <a:gd name="T74" fmla="*/ 141 w 405"/>
                <a:gd name="T75" fmla="*/ 270 h 336"/>
                <a:gd name="T76" fmla="*/ 141 w 405"/>
                <a:gd name="T77" fmla="*/ 292 h 336"/>
                <a:gd name="T78" fmla="*/ 238 w 405"/>
                <a:gd name="T79" fmla="*/ 292 h 336"/>
                <a:gd name="T80" fmla="*/ 238 w 405"/>
                <a:gd name="T81" fmla="*/ 314 h 336"/>
                <a:gd name="T82" fmla="*/ 254 w 405"/>
                <a:gd name="T83" fmla="*/ 314 h 336"/>
                <a:gd name="T84" fmla="*/ 254 w 405"/>
                <a:gd name="T85" fmla="*/ 336 h 336"/>
                <a:gd name="T86" fmla="*/ 405 w 405"/>
                <a:gd name="T87" fmla="*/ 336 h 3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</a:cxnLst>
              <a:rect l="0" t="0" r="r" b="b"/>
              <a:pathLst>
                <a:path w="405" h="336">
                  <a:moveTo>
                    <a:pt x="0" y="0"/>
                  </a:moveTo>
                  <a:lnTo>
                    <a:pt x="3" y="0"/>
                  </a:lnTo>
                  <a:lnTo>
                    <a:pt x="3" y="11"/>
                  </a:lnTo>
                  <a:lnTo>
                    <a:pt x="19" y="11"/>
                  </a:lnTo>
                  <a:lnTo>
                    <a:pt x="19" y="22"/>
                  </a:lnTo>
                  <a:lnTo>
                    <a:pt x="28" y="22"/>
                  </a:lnTo>
                  <a:lnTo>
                    <a:pt x="28" y="35"/>
                  </a:lnTo>
                  <a:lnTo>
                    <a:pt x="29" y="35"/>
                  </a:lnTo>
                  <a:lnTo>
                    <a:pt x="29" y="48"/>
                  </a:lnTo>
                  <a:lnTo>
                    <a:pt x="30" y="48"/>
                  </a:lnTo>
                  <a:lnTo>
                    <a:pt x="30" y="61"/>
                  </a:lnTo>
                  <a:lnTo>
                    <a:pt x="38" y="61"/>
                  </a:lnTo>
                  <a:lnTo>
                    <a:pt x="38" y="74"/>
                  </a:lnTo>
                  <a:lnTo>
                    <a:pt x="42" y="74"/>
                  </a:lnTo>
                  <a:lnTo>
                    <a:pt x="42" y="87"/>
                  </a:lnTo>
                  <a:lnTo>
                    <a:pt x="43" y="87"/>
                  </a:lnTo>
                  <a:lnTo>
                    <a:pt x="43" y="101"/>
                  </a:lnTo>
                  <a:lnTo>
                    <a:pt x="44" y="101"/>
                  </a:lnTo>
                  <a:lnTo>
                    <a:pt x="44" y="114"/>
                  </a:lnTo>
                  <a:lnTo>
                    <a:pt x="51" y="114"/>
                  </a:lnTo>
                  <a:lnTo>
                    <a:pt x="51" y="128"/>
                  </a:lnTo>
                  <a:lnTo>
                    <a:pt x="53" y="128"/>
                  </a:lnTo>
                  <a:lnTo>
                    <a:pt x="53" y="142"/>
                  </a:lnTo>
                  <a:lnTo>
                    <a:pt x="56" y="142"/>
                  </a:lnTo>
                  <a:lnTo>
                    <a:pt x="56" y="157"/>
                  </a:lnTo>
                  <a:lnTo>
                    <a:pt x="84" y="157"/>
                  </a:lnTo>
                  <a:lnTo>
                    <a:pt x="84" y="174"/>
                  </a:lnTo>
                  <a:lnTo>
                    <a:pt x="93" y="174"/>
                  </a:lnTo>
                  <a:lnTo>
                    <a:pt x="93" y="191"/>
                  </a:lnTo>
                  <a:lnTo>
                    <a:pt x="98" y="191"/>
                  </a:lnTo>
                  <a:lnTo>
                    <a:pt x="98" y="210"/>
                  </a:lnTo>
                  <a:lnTo>
                    <a:pt x="105" y="210"/>
                  </a:lnTo>
                  <a:lnTo>
                    <a:pt x="105" y="229"/>
                  </a:lnTo>
                  <a:lnTo>
                    <a:pt x="111" y="229"/>
                  </a:lnTo>
                  <a:lnTo>
                    <a:pt x="111" y="248"/>
                  </a:lnTo>
                  <a:lnTo>
                    <a:pt x="121" y="248"/>
                  </a:lnTo>
                  <a:lnTo>
                    <a:pt x="121" y="270"/>
                  </a:lnTo>
                  <a:lnTo>
                    <a:pt x="141" y="270"/>
                  </a:lnTo>
                  <a:lnTo>
                    <a:pt x="141" y="292"/>
                  </a:lnTo>
                  <a:lnTo>
                    <a:pt x="238" y="292"/>
                  </a:lnTo>
                  <a:lnTo>
                    <a:pt x="238" y="314"/>
                  </a:lnTo>
                  <a:lnTo>
                    <a:pt x="254" y="314"/>
                  </a:lnTo>
                  <a:lnTo>
                    <a:pt x="254" y="336"/>
                  </a:lnTo>
                  <a:lnTo>
                    <a:pt x="405" y="336"/>
                  </a:lnTo>
                </a:path>
              </a:pathLst>
            </a:custGeom>
            <a:noFill/>
            <a:ln w="28575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5BCC8610-BAAB-ECEF-F281-886F91E761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4674" y="4009886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9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CABD876D-EB7F-3B01-DE8E-CA0E41B8FA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5049" y="4009886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4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A37BCE32-C9CF-F31A-EBC9-00C8258379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1774" y="4009886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7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19A3F975-C0E2-C607-83AD-E53A232919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32149" y="4009886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49EC8CFC-4F2F-35B9-3F67-BE7D64A91C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27449" y="4009886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ECB55C4E-91AB-F716-FD52-F74D30FBCD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92586" y="4009886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AFCC7A64-BD1E-28EF-9FFF-0C3CD54C0B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54549" y="4009886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4E454A59-094A-2087-A606-81B3163477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4674" y="4225870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9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F8C4B319-6B6C-2BB9-0F23-AFCB7776E9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5049" y="4225870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9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FEED1B12-046B-BED5-36A3-FCDE25CD38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1774" y="4225870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AB5CDEF6-0D7A-CD94-4D54-0CFD48017D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0724" y="4225870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C86265B5-66B7-2B1A-0109-1068E2CF66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27449" y="4225870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8201A6A9-4700-0056-5F96-2C1ADA2068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92586" y="4225870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Rectangle 53">
              <a:extLst>
                <a:ext uri="{FF2B5EF4-FFF2-40B4-BE49-F238E27FC236}">
                  <a16:creationId xmlns:a16="http://schemas.microsoft.com/office/drawing/2014/main" id="{698B5DD9-AFD8-6CD9-9F6C-CCE0F85406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54549" y="4225870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201D28EF-A250-C419-5589-201E3FA73F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4674" y="4416687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3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id="{B812F942-1C9C-9310-8A58-AA7CFA3DA7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33624" y="4416687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Rectangle 56">
              <a:extLst>
                <a:ext uri="{FF2B5EF4-FFF2-40B4-BE49-F238E27FC236}">
                  <a16:creationId xmlns:a16="http://schemas.microsoft.com/office/drawing/2014/main" id="{11FA1F4A-35F8-AE35-3167-5BE1283095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00349" y="4416687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02A2670A-B840-8DA2-84F1-A928FF2EAF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0724" y="4416687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58">
              <a:extLst>
                <a:ext uri="{FF2B5EF4-FFF2-40B4-BE49-F238E27FC236}">
                  <a16:creationId xmlns:a16="http://schemas.microsoft.com/office/drawing/2014/main" id="{2CE90506-6F7C-3C05-E48F-635B42FEDD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27449" y="4416687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Rectangle 59">
              <a:extLst>
                <a:ext uri="{FF2B5EF4-FFF2-40B4-BE49-F238E27FC236}">
                  <a16:creationId xmlns:a16="http://schemas.microsoft.com/office/drawing/2014/main" id="{2E345AF6-818F-6A9E-17C5-1C9708E1D6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92586" y="4416687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F0B5E0DE-AD0C-8676-416E-4756EC5792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54549" y="4416687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id="{7037109F-C9A7-B33C-16CF-8C406B9020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4674" y="4607501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6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07FF05FD-AD1E-44A0-37B4-81F077AB75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5049" y="4607501"/>
              <a:ext cx="17953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63">
              <a:extLst>
                <a:ext uri="{FF2B5EF4-FFF2-40B4-BE49-F238E27FC236}">
                  <a16:creationId xmlns:a16="http://schemas.microsoft.com/office/drawing/2014/main" id="{000E634C-DCC1-8EC5-2A99-4024BE2F2B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00349" y="4607501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Rectangle 64">
              <a:extLst>
                <a:ext uri="{FF2B5EF4-FFF2-40B4-BE49-F238E27FC236}">
                  <a16:creationId xmlns:a16="http://schemas.microsoft.com/office/drawing/2014/main" id="{10D08888-F3D6-FBB6-F2FB-19C260DDC5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0724" y="4607501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ctangle 65">
              <a:extLst>
                <a:ext uri="{FF2B5EF4-FFF2-40B4-BE49-F238E27FC236}">
                  <a16:creationId xmlns:a16="http://schemas.microsoft.com/office/drawing/2014/main" id="{3355E549-A16D-A99E-731C-97DE9D4EF8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27449" y="4607501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66">
              <a:extLst>
                <a:ext uri="{FF2B5EF4-FFF2-40B4-BE49-F238E27FC236}">
                  <a16:creationId xmlns:a16="http://schemas.microsoft.com/office/drawing/2014/main" id="{A6B9CD28-D868-6331-632E-6F5DB61425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92586" y="4607501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Rectangle 67">
              <a:extLst>
                <a:ext uri="{FF2B5EF4-FFF2-40B4-BE49-F238E27FC236}">
                  <a16:creationId xmlns:a16="http://schemas.microsoft.com/office/drawing/2014/main" id="{9B5BB1D0-2887-32EB-2D2C-76686F8754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54549" y="4607501"/>
              <a:ext cx="8976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ja-JP" altLang="ja-JP" sz="14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Rectangle 72">
              <a:extLst>
                <a:ext uri="{FF2B5EF4-FFF2-40B4-BE49-F238E27FC236}">
                  <a16:creationId xmlns:a16="http://schemas.microsoft.com/office/drawing/2014/main" id="{CACFD19E-0B14-E843-A5EC-C557A6173B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5458" y="3730436"/>
              <a:ext cx="117333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at risk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Line 73">
              <a:extLst>
                <a:ext uri="{FF2B5EF4-FFF2-40B4-BE49-F238E27FC236}">
                  <a16:creationId xmlns:a16="http://schemas.microsoft.com/office/drawing/2014/main" id="{646526E1-DA4A-8E57-C2B7-845659F80C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54835" y="1274056"/>
              <a:ext cx="168275" cy="0"/>
            </a:xfrm>
            <a:prstGeom prst="line">
              <a:avLst/>
            </a:pr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Line 74">
              <a:extLst>
                <a:ext uri="{FF2B5EF4-FFF2-40B4-BE49-F238E27FC236}">
                  <a16:creationId xmlns:a16="http://schemas.microsoft.com/office/drawing/2014/main" id="{CCEBD5A9-33E1-6EA8-84E7-BE13818296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54835" y="1438120"/>
              <a:ext cx="168275" cy="0"/>
            </a:xfrm>
            <a:prstGeom prst="line">
              <a:avLst/>
            </a:prstGeom>
            <a:noFill/>
            <a:ln w="28575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Line 75">
              <a:extLst>
                <a:ext uri="{FF2B5EF4-FFF2-40B4-BE49-F238E27FC236}">
                  <a16:creationId xmlns:a16="http://schemas.microsoft.com/office/drawing/2014/main" id="{2B744AF0-A08F-937A-ADF8-FA49EA9708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54835" y="1599579"/>
              <a:ext cx="168275" cy="0"/>
            </a:xfrm>
            <a:prstGeom prst="line">
              <a:avLst/>
            </a:prstGeom>
            <a:noFill/>
            <a:ln w="28575" cap="rnd">
              <a:solidFill>
                <a:srgbClr val="61D04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Line 76">
              <a:extLst>
                <a:ext uri="{FF2B5EF4-FFF2-40B4-BE49-F238E27FC236}">
                  <a16:creationId xmlns:a16="http://schemas.microsoft.com/office/drawing/2014/main" id="{17B652C8-4E30-BA8C-2AA5-A0AC4F25CC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54835" y="1786200"/>
              <a:ext cx="168275" cy="0"/>
            </a:xfrm>
            <a:prstGeom prst="line">
              <a:avLst/>
            </a:prstGeom>
            <a:noFill/>
            <a:ln w="28575" cap="rnd">
              <a:solidFill>
                <a:srgbClr val="2297E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4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Rectangle 78">
              <a:extLst>
                <a:ext uri="{FF2B5EF4-FFF2-40B4-BE49-F238E27FC236}">
                  <a16:creationId xmlns:a16="http://schemas.microsoft.com/office/drawing/2014/main" id="{297F8A97-17D0-D423-6F5A-8253748C5C72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6359569" y="1132250"/>
              <a:ext cx="946717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T1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Rectangle 79">
              <a:extLst>
                <a:ext uri="{FF2B5EF4-FFF2-40B4-BE49-F238E27FC236}">
                  <a16:creationId xmlns:a16="http://schemas.microsoft.com/office/drawing/2014/main" id="{14CC8955-FFE6-B9AE-5E93-884D96C7DF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3787" y="1314011"/>
              <a:ext cx="29014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T2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80">
              <a:extLst>
                <a:ext uri="{FF2B5EF4-FFF2-40B4-BE49-F238E27FC236}">
                  <a16:creationId xmlns:a16="http://schemas.microsoft.com/office/drawing/2014/main" id="{34570C96-7401-0352-EF8D-6A16CCF658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72703" y="1494369"/>
              <a:ext cx="29014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T3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81">
              <a:extLst>
                <a:ext uri="{FF2B5EF4-FFF2-40B4-BE49-F238E27FC236}">
                  <a16:creationId xmlns:a16="http://schemas.microsoft.com/office/drawing/2014/main" id="{5CD7D68E-E153-ECF2-4AF7-B02E8B41B0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52370" y="1680452"/>
              <a:ext cx="29014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T4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79">
              <a:extLst>
                <a:ext uri="{FF2B5EF4-FFF2-40B4-BE49-F238E27FC236}">
                  <a16:creationId xmlns:a16="http://schemas.microsoft.com/office/drawing/2014/main" id="{1D2EC744-AF05-B3C1-33B4-1007155080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38219" y="4217233"/>
              <a:ext cx="29014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T2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Rectangle 80">
              <a:extLst>
                <a:ext uri="{FF2B5EF4-FFF2-40B4-BE49-F238E27FC236}">
                  <a16:creationId xmlns:a16="http://schemas.microsoft.com/office/drawing/2014/main" id="{0FB40A71-0295-E08C-81DF-7BE32F79BD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47135" y="4397591"/>
              <a:ext cx="29014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T3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81">
              <a:extLst>
                <a:ext uri="{FF2B5EF4-FFF2-40B4-BE49-F238E27FC236}">
                  <a16:creationId xmlns:a16="http://schemas.microsoft.com/office/drawing/2014/main" id="{FC389698-6B51-9592-A927-334BDFF098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26802" y="4608838"/>
              <a:ext cx="29014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T4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Rectangle 78">
              <a:extLst>
                <a:ext uri="{FF2B5EF4-FFF2-40B4-BE49-F238E27FC236}">
                  <a16:creationId xmlns:a16="http://schemas.microsoft.com/office/drawing/2014/main" id="{21D7258B-F2F5-7657-39B3-673D101B32A7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3548571" y="4005742"/>
              <a:ext cx="36931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r>
                <a:rPr kumimoji="0" lang="ja-JP" altLang="ja-JP" sz="14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rT1</a:t>
              </a:r>
              <a:endParaRPr kumimoji="0" lang="ja-JP" altLang="ja-JP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D05AE48D-3783-B687-98D3-B412DDD35443}"/>
                </a:ext>
              </a:extLst>
            </p:cNvPr>
            <p:cNvSpPr txBox="1"/>
            <p:nvPr/>
          </p:nvSpPr>
          <p:spPr>
            <a:xfrm>
              <a:off x="4117785" y="3213002"/>
              <a:ext cx="1942056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 = </a:t>
              </a:r>
              <a:r>
                <a:rPr lang="ja-JP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627</a:t>
              </a:r>
            </a:p>
          </p:txBody>
        </p:sp>
      </p:grp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EE5E5977-6787-C84F-177F-809436B17C35}"/>
              </a:ext>
            </a:extLst>
          </p:cNvPr>
          <p:cNvSpPr txBox="1"/>
          <p:nvPr/>
        </p:nvSpPr>
        <p:spPr>
          <a:xfrm>
            <a:off x="1785294" y="316736"/>
            <a:ext cx="8118633" cy="8735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. </a:t>
            </a:r>
            <a:r>
              <a:rPr lang="en-US" altLang="ja-JP" sz="1800" kern="100" dirty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verall survival rate (OS)</a:t>
            </a:r>
            <a:r>
              <a:rPr lang="en-US" altLang="ja-JP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ccording to </a:t>
            </a:r>
            <a:r>
              <a:rPr lang="en-US" altLang="ja-JP" kern="100" dirty="0" err="1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T</a:t>
            </a:r>
            <a:r>
              <a:rPr lang="en-US" altLang="ja-JP" kern="100" dirty="0"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category. 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5966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0</TotalTime>
  <Words>73</Words>
  <Application>Microsoft Office PowerPoint</Application>
  <PresentationFormat>ワイド画面</PresentationFormat>
  <Paragraphs>5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entury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ewlett-Packard Company</dc:creator>
  <cp:lastModifiedBy>Hewlett-Packard Company</cp:lastModifiedBy>
  <cp:revision>6</cp:revision>
  <dcterms:created xsi:type="dcterms:W3CDTF">2022-11-19T07:35:51Z</dcterms:created>
  <dcterms:modified xsi:type="dcterms:W3CDTF">2022-11-22T07:04:04Z</dcterms:modified>
</cp:coreProperties>
</file>